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239"/>
    <p:restoredTop sz="94668"/>
  </p:normalViewPr>
  <p:slideViewPr>
    <p:cSldViewPr snapToGrid="0">
      <p:cViewPr varScale="1">
        <p:scale>
          <a:sx n="89" d="100"/>
          <a:sy n="89" d="100"/>
        </p:scale>
        <p:origin x="28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92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80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3871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1917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6148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6156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2602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8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9666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607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011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F03F22-C291-A043-9BCB-CC9B2784972E}" type="datetimeFigureOut">
              <a:rPr kumimoji="1" lang="ja-JP" altLang="en-US" smtClean="0"/>
              <a:t>2026/4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55D89F-CC1D-2941-8927-42E5D86E2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252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2" name="グループ化 171">
            <a:extLst>
              <a:ext uri="{FF2B5EF4-FFF2-40B4-BE49-F238E27FC236}">
                <a16:creationId xmlns:a16="http://schemas.microsoft.com/office/drawing/2014/main" id="{1668D82F-9A38-6A2F-0801-1A0AC003DD4E}"/>
              </a:ext>
            </a:extLst>
          </p:cNvPr>
          <p:cNvGrpSpPr/>
          <p:nvPr/>
        </p:nvGrpSpPr>
        <p:grpSpPr>
          <a:xfrm>
            <a:off x="393369" y="2402465"/>
            <a:ext cx="2543244" cy="3103433"/>
            <a:chOff x="476792" y="2402465"/>
            <a:chExt cx="2543244" cy="3103433"/>
          </a:xfrm>
        </p:grpSpPr>
        <p:pic>
          <p:nvPicPr>
            <p:cNvPr id="50" name="図 49">
              <a:extLst>
                <a:ext uri="{FF2B5EF4-FFF2-40B4-BE49-F238E27FC236}">
                  <a16:creationId xmlns:a16="http://schemas.microsoft.com/office/drawing/2014/main" id="{3824B749-24FB-BC61-B382-E680F2484B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82377" y="2603279"/>
              <a:ext cx="2090511" cy="2660650"/>
            </a:xfrm>
            <a:prstGeom prst="rect">
              <a:avLst/>
            </a:prstGeom>
          </p:spPr>
        </p:pic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D35F5CB4-5551-0BEA-F053-43DEE520DA46}"/>
                </a:ext>
              </a:extLst>
            </p:cNvPr>
            <p:cNvCxnSpPr>
              <a:cxnSpLocks/>
            </p:cNvCxnSpPr>
            <p:nvPr/>
          </p:nvCxnSpPr>
          <p:spPr>
            <a:xfrm>
              <a:off x="943976" y="2614339"/>
              <a:ext cx="1863876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A2719535-4302-E851-AA2C-655A66212459}"/>
                </a:ext>
              </a:extLst>
            </p:cNvPr>
            <p:cNvCxnSpPr>
              <a:cxnSpLocks/>
            </p:cNvCxnSpPr>
            <p:nvPr/>
          </p:nvCxnSpPr>
          <p:spPr>
            <a:xfrm>
              <a:off x="1117301" y="5215807"/>
              <a:ext cx="1594093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5" name="グループ化 124">
              <a:extLst>
                <a:ext uri="{FF2B5EF4-FFF2-40B4-BE49-F238E27FC236}">
                  <a16:creationId xmlns:a16="http://schemas.microsoft.com/office/drawing/2014/main" id="{F245151E-44A1-39AE-1D97-9C5986A4094D}"/>
                </a:ext>
              </a:extLst>
            </p:cNvPr>
            <p:cNvGrpSpPr/>
            <p:nvPr/>
          </p:nvGrpSpPr>
          <p:grpSpPr>
            <a:xfrm>
              <a:off x="476792" y="2871697"/>
              <a:ext cx="385713" cy="982384"/>
              <a:chOff x="324358" y="1075881"/>
              <a:chExt cx="385713" cy="999953"/>
            </a:xfrm>
          </p:grpSpPr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D347547C-92A1-EA8E-A562-596DCE75C3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223" y="1949743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4D5CE593-FBA8-405D-0AF2-3AFF19D7D9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223" y="1819207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16E40658-A74E-8320-3FC5-A40E5A8F81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223" y="1262905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08BAB167-1DE3-D852-2729-5B68B27856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223" y="1412017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FA51889B-59E2-F226-7F28-D42C58E7A1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223" y="1501922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91768011-E0D3-7ECC-2AEA-ECCA32B10AB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223" y="1227834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>
                <a:extLst>
                  <a:ext uri="{FF2B5EF4-FFF2-40B4-BE49-F238E27FC236}">
                    <a16:creationId xmlns:a16="http://schemas.microsoft.com/office/drawing/2014/main" id="{A8D1C4E7-589F-B54A-8CF1-E900EDD9761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3223" y="1653916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857758E6-7640-6C6C-34E6-8486608B289B}"/>
                  </a:ext>
                </a:extLst>
              </p:cNvPr>
              <p:cNvSpPr txBox="1"/>
              <p:nvPr/>
            </p:nvSpPr>
            <p:spPr>
              <a:xfrm>
                <a:off x="324358" y="107588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1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0DAD2FB2-0887-2795-7378-FBF57B4C982C}"/>
                  </a:ext>
                </a:extLst>
              </p:cNvPr>
              <p:cNvSpPr txBox="1"/>
              <p:nvPr/>
            </p:nvSpPr>
            <p:spPr>
              <a:xfrm>
                <a:off x="324358" y="119657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207728E9-DCFA-D7DB-D831-CD85972ABA44}"/>
                  </a:ext>
                </a:extLst>
              </p:cNvPr>
              <p:cNvSpPr txBox="1"/>
              <p:nvPr/>
            </p:nvSpPr>
            <p:spPr>
              <a:xfrm>
                <a:off x="382066" y="130429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FEF83170-D936-2208-950A-7E7DA8F211A3}"/>
                  </a:ext>
                </a:extLst>
              </p:cNvPr>
              <p:cNvSpPr txBox="1"/>
              <p:nvPr/>
            </p:nvSpPr>
            <p:spPr>
              <a:xfrm>
                <a:off x="382066" y="139952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2DAC1800-6F95-E013-E1A6-D27EB7FCE5E3}"/>
                  </a:ext>
                </a:extLst>
              </p:cNvPr>
              <p:cNvSpPr txBox="1"/>
              <p:nvPr/>
            </p:nvSpPr>
            <p:spPr>
              <a:xfrm>
                <a:off x="382066" y="155504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C4EC9FCA-397B-26BE-3AA9-A7E7FC900654}"/>
                  </a:ext>
                </a:extLst>
              </p:cNvPr>
              <p:cNvSpPr txBox="1"/>
              <p:nvPr/>
            </p:nvSpPr>
            <p:spPr>
              <a:xfrm>
                <a:off x="382066" y="170487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08239E48-DEAD-51EE-3177-46A3632FB756}"/>
                  </a:ext>
                </a:extLst>
              </p:cNvPr>
              <p:cNvSpPr txBox="1"/>
              <p:nvPr/>
            </p:nvSpPr>
            <p:spPr>
              <a:xfrm>
                <a:off x="382066" y="18603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EB2F71A3-21DB-8F79-38CF-BD2524BDC670}"/>
                </a:ext>
              </a:extLst>
            </p:cNvPr>
            <p:cNvSpPr txBox="1"/>
            <p:nvPr/>
          </p:nvSpPr>
          <p:spPr>
            <a:xfrm>
              <a:off x="1117301" y="2402465"/>
              <a:ext cx="38505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5C1802D8-6D68-EA42-D49F-C711905D94B1}"/>
                </a:ext>
              </a:extLst>
            </p:cNvPr>
            <p:cNvSpPr txBox="1"/>
            <p:nvPr/>
          </p:nvSpPr>
          <p:spPr>
            <a:xfrm>
              <a:off x="1334896" y="2402465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1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325DBB57-EE2D-985C-3CE6-2848B53689F4}"/>
                </a:ext>
              </a:extLst>
            </p:cNvPr>
            <p:cNvSpPr txBox="1"/>
            <p:nvPr/>
          </p:nvSpPr>
          <p:spPr>
            <a:xfrm>
              <a:off x="1557150" y="2402465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2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9D29BE37-5451-CD8A-975C-80C9914C6EFB}"/>
                </a:ext>
              </a:extLst>
            </p:cNvPr>
            <p:cNvSpPr txBox="1"/>
            <p:nvPr/>
          </p:nvSpPr>
          <p:spPr>
            <a:xfrm>
              <a:off x="1792383" y="2402465"/>
              <a:ext cx="4160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3</a:t>
              </a: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AF65EB81-E003-AD43-4A21-89F226E76CA8}"/>
                </a:ext>
              </a:extLst>
            </p:cNvPr>
            <p:cNvSpPr txBox="1"/>
            <p:nvPr/>
          </p:nvSpPr>
          <p:spPr>
            <a:xfrm>
              <a:off x="2025610" y="2402465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4</a:t>
              </a: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5804AEC8-6F4F-E382-5B13-87E3431F0D1C}"/>
                </a:ext>
              </a:extLst>
            </p:cNvPr>
            <p:cNvSpPr txBox="1"/>
            <p:nvPr/>
          </p:nvSpPr>
          <p:spPr>
            <a:xfrm>
              <a:off x="2277914" y="2402465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5</a:t>
              </a: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45D08CD8-DD6A-5476-226A-8207CF459DB0}"/>
                </a:ext>
              </a:extLst>
            </p:cNvPr>
            <p:cNvSpPr txBox="1"/>
            <p:nvPr/>
          </p:nvSpPr>
          <p:spPr>
            <a:xfrm>
              <a:off x="2085340" y="5259677"/>
              <a:ext cx="9346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nti-AQP4</a:t>
              </a:r>
              <a:endParaRPr kumimoji="1" lang="ja-JP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1AE798FC-DAF3-CAD0-92BC-3D61BFCB8872}"/>
                </a:ext>
              </a:extLst>
            </p:cNvPr>
            <p:cNvSpPr txBox="1"/>
            <p:nvPr/>
          </p:nvSpPr>
          <p:spPr>
            <a:xfrm>
              <a:off x="515360" y="2602391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3B4DB990-9E27-4B9D-E139-35134DBB9D2C}"/>
              </a:ext>
            </a:extLst>
          </p:cNvPr>
          <p:cNvGrpSpPr/>
          <p:nvPr/>
        </p:nvGrpSpPr>
        <p:grpSpPr>
          <a:xfrm>
            <a:off x="480026" y="720147"/>
            <a:ext cx="2754269" cy="1120120"/>
            <a:chOff x="3429000" y="692150"/>
            <a:chExt cx="2443773" cy="993846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505E0A00-5F89-A9BA-CB1C-576FD94B3B8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29000" y="692150"/>
              <a:ext cx="2443773" cy="993846"/>
            </a:xfrm>
            <a:prstGeom prst="rect">
              <a:avLst/>
            </a:prstGeom>
          </p:spPr>
        </p:pic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117D5EE4-BBBD-EA97-7742-03E340756EAA}"/>
                </a:ext>
              </a:extLst>
            </p:cNvPr>
            <p:cNvCxnSpPr/>
            <p:nvPr/>
          </p:nvCxnSpPr>
          <p:spPr>
            <a:xfrm flipV="1">
              <a:off x="3794161" y="867508"/>
              <a:ext cx="1436077" cy="6447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D164E4AA-2823-9623-DEDD-3614E5375074}"/>
                </a:ext>
              </a:extLst>
            </p:cNvPr>
            <p:cNvCxnSpPr>
              <a:cxnSpLocks/>
            </p:cNvCxnSpPr>
            <p:nvPr/>
          </p:nvCxnSpPr>
          <p:spPr>
            <a:xfrm>
              <a:off x="3794160" y="1524000"/>
              <a:ext cx="1436077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7" name="グループ化 106">
            <a:extLst>
              <a:ext uri="{FF2B5EF4-FFF2-40B4-BE49-F238E27FC236}">
                <a16:creationId xmlns:a16="http://schemas.microsoft.com/office/drawing/2014/main" id="{504438BB-BBC7-B739-A85B-48D2EB7312D5}"/>
              </a:ext>
            </a:extLst>
          </p:cNvPr>
          <p:cNvGrpSpPr/>
          <p:nvPr/>
        </p:nvGrpSpPr>
        <p:grpSpPr>
          <a:xfrm>
            <a:off x="78418" y="1130719"/>
            <a:ext cx="385713" cy="530947"/>
            <a:chOff x="2947565" y="1872987"/>
            <a:chExt cx="385713" cy="530947"/>
          </a:xfrm>
        </p:grpSpPr>
        <p:grpSp>
          <p:nvGrpSpPr>
            <p:cNvPr id="104" name="グループ化 103">
              <a:extLst>
                <a:ext uri="{FF2B5EF4-FFF2-40B4-BE49-F238E27FC236}">
                  <a16:creationId xmlns:a16="http://schemas.microsoft.com/office/drawing/2014/main" id="{18E9885E-D5AA-78CD-F99A-42B47768DA26}"/>
                </a:ext>
              </a:extLst>
            </p:cNvPr>
            <p:cNvGrpSpPr/>
            <p:nvPr/>
          </p:nvGrpSpPr>
          <p:grpSpPr>
            <a:xfrm>
              <a:off x="2947565" y="1872987"/>
              <a:ext cx="385713" cy="416613"/>
              <a:chOff x="489577" y="1228281"/>
              <a:chExt cx="385713" cy="443858"/>
            </a:xfrm>
          </p:grpSpPr>
          <p:cxnSp>
            <p:nvCxnSpPr>
              <p:cNvPr id="97" name="直線コネクタ 96">
                <a:extLst>
                  <a:ext uri="{FF2B5EF4-FFF2-40B4-BE49-F238E27FC236}">
                    <a16:creationId xmlns:a16="http://schemas.microsoft.com/office/drawing/2014/main" id="{77740A41-76AE-DAF4-0013-7947E7EAC7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8442" y="1415305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線コネクタ 97">
                <a:extLst>
                  <a:ext uri="{FF2B5EF4-FFF2-40B4-BE49-F238E27FC236}">
                    <a16:creationId xmlns:a16="http://schemas.microsoft.com/office/drawing/2014/main" id="{23711FE0-F37E-2289-B0D4-47300BC8F4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8442" y="1564417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線コネクタ 98">
                <a:extLst>
                  <a:ext uri="{FF2B5EF4-FFF2-40B4-BE49-F238E27FC236}">
                    <a16:creationId xmlns:a16="http://schemas.microsoft.com/office/drawing/2014/main" id="{E5141D8A-74F7-B022-F368-0160857536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8442" y="1654322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直線コネクタ 99">
                <a:extLst>
                  <a:ext uri="{FF2B5EF4-FFF2-40B4-BE49-F238E27FC236}">
                    <a16:creationId xmlns:a16="http://schemas.microsoft.com/office/drawing/2014/main" id="{C6CD9807-1EAC-6560-6425-BC1D7D999C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8442" y="1380234"/>
                <a:ext cx="8684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テキスト ボックス 100">
                <a:extLst>
                  <a:ext uri="{FF2B5EF4-FFF2-40B4-BE49-F238E27FC236}">
                    <a16:creationId xmlns:a16="http://schemas.microsoft.com/office/drawing/2014/main" id="{69D13492-7BA3-1D33-84F9-1CA250434B97}"/>
                  </a:ext>
                </a:extLst>
              </p:cNvPr>
              <p:cNvSpPr txBox="1"/>
              <p:nvPr/>
            </p:nvSpPr>
            <p:spPr>
              <a:xfrm>
                <a:off x="489577" y="122828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1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テキスト ボックス 101">
                <a:extLst>
                  <a:ext uri="{FF2B5EF4-FFF2-40B4-BE49-F238E27FC236}">
                    <a16:creationId xmlns:a16="http://schemas.microsoft.com/office/drawing/2014/main" id="{16A29CB8-F537-17E4-8977-9B70D7E9AB23}"/>
                  </a:ext>
                </a:extLst>
              </p:cNvPr>
              <p:cNvSpPr txBox="1"/>
              <p:nvPr/>
            </p:nvSpPr>
            <p:spPr>
              <a:xfrm>
                <a:off x="489577" y="134897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4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59508D26-79B1-4CFD-E93D-AB25E54EE6AA}"/>
                  </a:ext>
                </a:extLst>
              </p:cNvPr>
              <p:cNvSpPr txBox="1"/>
              <p:nvPr/>
            </p:nvSpPr>
            <p:spPr>
              <a:xfrm>
                <a:off x="547285" y="145669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09E2CDD2-EDD6-A9EE-018C-306C5CA12C8C}"/>
                </a:ext>
              </a:extLst>
            </p:cNvPr>
            <p:cNvSpPr txBox="1"/>
            <p:nvPr/>
          </p:nvSpPr>
          <p:spPr>
            <a:xfrm>
              <a:off x="3006459" y="21884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71F11E06-45D8-EBE0-6C61-07597996CA75}"/>
              </a:ext>
            </a:extLst>
          </p:cNvPr>
          <p:cNvSpPr txBox="1"/>
          <p:nvPr/>
        </p:nvSpPr>
        <p:spPr>
          <a:xfrm>
            <a:off x="2360247" y="1887082"/>
            <a:ext cx="9346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nti-HSP70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8D7783CA-7B60-D3F6-1BA9-15DC2208D39B}"/>
              </a:ext>
            </a:extLst>
          </p:cNvPr>
          <p:cNvSpPr txBox="1"/>
          <p:nvPr/>
        </p:nvSpPr>
        <p:spPr>
          <a:xfrm>
            <a:off x="106206" y="720146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D6EC00D1-527A-B0FC-6EB3-306A3E0D922E}"/>
              </a:ext>
            </a:extLst>
          </p:cNvPr>
          <p:cNvGrpSpPr/>
          <p:nvPr/>
        </p:nvGrpSpPr>
        <p:grpSpPr>
          <a:xfrm>
            <a:off x="3707796" y="766807"/>
            <a:ext cx="2644214" cy="1149352"/>
            <a:chOff x="3044066" y="3536950"/>
            <a:chExt cx="2766183" cy="1202368"/>
          </a:xfrm>
        </p:grpSpPr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332950E3-8FAE-120E-B26D-062461AABD8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44066" y="3536950"/>
              <a:ext cx="2766183" cy="1202368"/>
            </a:xfrm>
            <a:prstGeom prst="rect">
              <a:avLst/>
            </a:prstGeom>
          </p:spPr>
        </p:pic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809D5C35-844F-E2EC-8652-F066940C3191}"/>
                </a:ext>
              </a:extLst>
            </p:cNvPr>
            <p:cNvCxnSpPr>
              <a:cxnSpLocks/>
            </p:cNvCxnSpPr>
            <p:nvPr/>
          </p:nvCxnSpPr>
          <p:spPr>
            <a:xfrm rot="60000">
              <a:off x="3521915" y="3627210"/>
              <a:ext cx="1752107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25467B4F-F162-02A3-66A1-D3D0CAB62CD7}"/>
                </a:ext>
              </a:extLst>
            </p:cNvPr>
            <p:cNvCxnSpPr>
              <a:cxnSpLocks/>
            </p:cNvCxnSpPr>
            <p:nvPr/>
          </p:nvCxnSpPr>
          <p:spPr>
            <a:xfrm rot="60000">
              <a:off x="3521915" y="4668268"/>
              <a:ext cx="1752107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4" name="グループ化 123">
            <a:extLst>
              <a:ext uri="{FF2B5EF4-FFF2-40B4-BE49-F238E27FC236}">
                <a16:creationId xmlns:a16="http://schemas.microsoft.com/office/drawing/2014/main" id="{0F0E9B98-C1A0-8573-E72D-5C9A0EC97393}"/>
              </a:ext>
            </a:extLst>
          </p:cNvPr>
          <p:cNvGrpSpPr/>
          <p:nvPr/>
        </p:nvGrpSpPr>
        <p:grpSpPr>
          <a:xfrm>
            <a:off x="3408526" y="771828"/>
            <a:ext cx="286492" cy="454879"/>
            <a:chOff x="547285" y="1707442"/>
            <a:chExt cx="328005" cy="520792"/>
          </a:xfrm>
        </p:grpSpPr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F8D3792F-E235-A047-CC1E-80437198E556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2102143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BD475F15-2FA2-5B39-B6C2-8F54F03C16BA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971607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C2F8DB6D-8B03-00B5-7163-AD030B9F1028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806316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3593B796-4741-FD29-07FF-8260A3509BBC}"/>
                </a:ext>
              </a:extLst>
            </p:cNvPr>
            <p:cNvSpPr txBox="1"/>
            <p:nvPr/>
          </p:nvSpPr>
          <p:spPr>
            <a:xfrm>
              <a:off x="547285" y="17074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94EA1E1B-4576-C56E-2B14-6B72C83FA374}"/>
                </a:ext>
              </a:extLst>
            </p:cNvPr>
            <p:cNvSpPr txBox="1"/>
            <p:nvPr/>
          </p:nvSpPr>
          <p:spPr>
            <a:xfrm>
              <a:off x="547285" y="185727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71FE8C7A-479E-E086-3955-6159E1AB0901}"/>
                </a:ext>
              </a:extLst>
            </p:cNvPr>
            <p:cNvSpPr txBox="1"/>
            <p:nvPr/>
          </p:nvSpPr>
          <p:spPr>
            <a:xfrm>
              <a:off x="547285" y="20127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A55674D9-7B7A-6944-3996-6D07E28C0372}"/>
              </a:ext>
            </a:extLst>
          </p:cNvPr>
          <p:cNvSpPr txBox="1"/>
          <p:nvPr/>
        </p:nvSpPr>
        <p:spPr>
          <a:xfrm>
            <a:off x="5561690" y="1887082"/>
            <a:ext cx="9482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kumimoji="1" lang="el-GR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39D0ADAB-C26E-2F97-AD7E-423EA44A7A3E}"/>
              </a:ext>
            </a:extLst>
          </p:cNvPr>
          <p:cNvSpPr txBox="1"/>
          <p:nvPr/>
        </p:nvSpPr>
        <p:spPr>
          <a:xfrm>
            <a:off x="3352667" y="570559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8A4A9C1E-D7FE-F1B6-3D0C-CA7A7E52C073}"/>
              </a:ext>
            </a:extLst>
          </p:cNvPr>
          <p:cNvGrpSpPr/>
          <p:nvPr/>
        </p:nvGrpSpPr>
        <p:grpSpPr>
          <a:xfrm>
            <a:off x="3972058" y="2580577"/>
            <a:ext cx="1855995" cy="2660650"/>
            <a:chOff x="435522" y="3480989"/>
            <a:chExt cx="1855995" cy="2660650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FFFB59F4-F3C9-7B98-1D56-2B636E88694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5522" y="3480989"/>
              <a:ext cx="1855995" cy="2660650"/>
            </a:xfrm>
            <a:prstGeom prst="rect">
              <a:avLst/>
            </a:prstGeom>
          </p:spPr>
        </p:pic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6A93A1C0-8352-3340-69D4-2152CDDB06CD}"/>
                </a:ext>
              </a:extLst>
            </p:cNvPr>
            <p:cNvCxnSpPr>
              <a:cxnSpLocks/>
            </p:cNvCxnSpPr>
            <p:nvPr/>
          </p:nvCxnSpPr>
          <p:spPr>
            <a:xfrm>
              <a:off x="697424" y="6078368"/>
              <a:ext cx="1594093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4B7F84DD-3FD0-F209-FA49-38852057F087}"/>
                </a:ext>
              </a:extLst>
            </p:cNvPr>
            <p:cNvCxnSpPr>
              <a:cxnSpLocks/>
            </p:cNvCxnSpPr>
            <p:nvPr/>
          </p:nvCxnSpPr>
          <p:spPr>
            <a:xfrm>
              <a:off x="697423" y="3588307"/>
              <a:ext cx="1594093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2" name="グループ化 91">
            <a:extLst>
              <a:ext uri="{FF2B5EF4-FFF2-40B4-BE49-F238E27FC236}">
                <a16:creationId xmlns:a16="http://schemas.microsoft.com/office/drawing/2014/main" id="{351F723B-CE09-E0BA-9187-E882E546D9A9}"/>
              </a:ext>
            </a:extLst>
          </p:cNvPr>
          <p:cNvGrpSpPr/>
          <p:nvPr/>
        </p:nvGrpSpPr>
        <p:grpSpPr>
          <a:xfrm>
            <a:off x="3566901" y="2859791"/>
            <a:ext cx="385713" cy="931719"/>
            <a:chOff x="489577" y="1228281"/>
            <a:chExt cx="385713" cy="999953"/>
          </a:xfrm>
        </p:grpSpPr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A7167108-A84F-6417-1347-FA8ABDDB2E46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2102143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4CDA91E3-C114-7001-F1EB-02E6FDD4B097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971607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8B6C3C02-2BF0-CF2F-19EE-E8281C1AD841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415305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9CB45EFB-09BC-D929-9DC8-ACB76735CF16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564417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9DF65A70-D256-A7FF-8A5D-14CC9D10C72F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654322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E49BE506-2B68-21E4-6AA8-48CDF865DE62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380234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FC4827F0-A9C3-3518-1F8E-69B47F58A7BC}"/>
                </a:ext>
              </a:extLst>
            </p:cNvPr>
            <p:cNvCxnSpPr>
              <a:cxnSpLocks/>
            </p:cNvCxnSpPr>
            <p:nvPr/>
          </p:nvCxnSpPr>
          <p:spPr>
            <a:xfrm>
              <a:off x="788442" y="1806316"/>
              <a:ext cx="8684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48B7F539-0B8B-9D30-4C45-7E574BFDB631}"/>
                </a:ext>
              </a:extLst>
            </p:cNvPr>
            <p:cNvSpPr txBox="1"/>
            <p:nvPr/>
          </p:nvSpPr>
          <p:spPr>
            <a:xfrm>
              <a:off x="489577" y="1228281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1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C96D3C9C-1AB0-0A2D-434D-099640E03DC3}"/>
                </a:ext>
              </a:extLst>
            </p:cNvPr>
            <p:cNvSpPr txBox="1"/>
            <p:nvPr/>
          </p:nvSpPr>
          <p:spPr>
            <a:xfrm>
              <a:off x="489577" y="1348973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A3DD87FF-3682-50AD-8D88-A518AA67E0ED}"/>
                </a:ext>
              </a:extLst>
            </p:cNvPr>
            <p:cNvSpPr txBox="1"/>
            <p:nvPr/>
          </p:nvSpPr>
          <p:spPr>
            <a:xfrm>
              <a:off x="547285" y="145669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C3C5CFD7-2A43-F8B9-27E3-5ECB71CF8605}"/>
                </a:ext>
              </a:extLst>
            </p:cNvPr>
            <p:cNvSpPr txBox="1"/>
            <p:nvPr/>
          </p:nvSpPr>
          <p:spPr>
            <a:xfrm>
              <a:off x="547285" y="155192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69692BDA-FF7E-0DE4-7494-A7A8F27C6084}"/>
                </a:ext>
              </a:extLst>
            </p:cNvPr>
            <p:cNvSpPr txBox="1"/>
            <p:nvPr/>
          </p:nvSpPr>
          <p:spPr>
            <a:xfrm>
              <a:off x="547285" y="170744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118093D6-357D-55CC-B4A9-BF57D30CF9B2}"/>
                </a:ext>
              </a:extLst>
            </p:cNvPr>
            <p:cNvSpPr txBox="1"/>
            <p:nvPr/>
          </p:nvSpPr>
          <p:spPr>
            <a:xfrm>
              <a:off x="547285" y="185727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0A80E8A7-D022-699A-DA46-9F6B86E6E393}"/>
                </a:ext>
              </a:extLst>
            </p:cNvPr>
            <p:cNvSpPr txBox="1"/>
            <p:nvPr/>
          </p:nvSpPr>
          <p:spPr>
            <a:xfrm>
              <a:off x="547285" y="201279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F359E15E-DD6D-5908-A2F0-BA0A3D692886}"/>
              </a:ext>
            </a:extLst>
          </p:cNvPr>
          <p:cNvSpPr txBox="1"/>
          <p:nvPr/>
        </p:nvSpPr>
        <p:spPr>
          <a:xfrm>
            <a:off x="5175532" y="5259677"/>
            <a:ext cx="9482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kumimoji="1" lang="el-GR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4AF397FD-A266-5915-1E9C-998FC7214206}"/>
              </a:ext>
            </a:extLst>
          </p:cNvPr>
          <p:cNvSpPr txBox="1"/>
          <p:nvPr/>
        </p:nvSpPr>
        <p:spPr>
          <a:xfrm>
            <a:off x="3608374" y="2583126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3" name="グループ化 142">
            <a:extLst>
              <a:ext uri="{FF2B5EF4-FFF2-40B4-BE49-F238E27FC236}">
                <a16:creationId xmlns:a16="http://schemas.microsoft.com/office/drawing/2014/main" id="{B67B54A3-3513-DF4E-FE55-4BCDBAADDA60}"/>
              </a:ext>
            </a:extLst>
          </p:cNvPr>
          <p:cNvGrpSpPr/>
          <p:nvPr/>
        </p:nvGrpSpPr>
        <p:grpSpPr>
          <a:xfrm>
            <a:off x="827159" y="612424"/>
            <a:ext cx="1728228" cy="215444"/>
            <a:chOff x="1178622" y="2836148"/>
            <a:chExt cx="1567616" cy="215444"/>
          </a:xfrm>
        </p:grpSpPr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6EEBC8C9-5FBC-0599-3308-90B2605BED0F}"/>
                </a:ext>
              </a:extLst>
            </p:cNvPr>
            <p:cNvSpPr txBox="1"/>
            <p:nvPr/>
          </p:nvSpPr>
          <p:spPr>
            <a:xfrm>
              <a:off x="1178622" y="2836148"/>
              <a:ext cx="38505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A37A605D-D08F-4B06-CE82-49750AB55EBD}"/>
                </a:ext>
              </a:extLst>
            </p:cNvPr>
            <p:cNvSpPr txBox="1"/>
            <p:nvPr/>
          </p:nvSpPr>
          <p:spPr>
            <a:xfrm>
              <a:off x="1396217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1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CFFBB081-D6F8-36F0-F0C5-F4290277B0B8}"/>
                </a:ext>
              </a:extLst>
            </p:cNvPr>
            <p:cNvSpPr txBox="1"/>
            <p:nvPr/>
          </p:nvSpPr>
          <p:spPr>
            <a:xfrm>
              <a:off x="1618471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2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F4681E16-FBC5-E21C-3007-9A7A056CA0E4}"/>
                </a:ext>
              </a:extLst>
            </p:cNvPr>
            <p:cNvSpPr txBox="1"/>
            <p:nvPr/>
          </p:nvSpPr>
          <p:spPr>
            <a:xfrm>
              <a:off x="1853704" y="2836148"/>
              <a:ext cx="4160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3</a:t>
              </a: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B240FD38-9B5D-57C5-12F0-1227A02DA7CA}"/>
                </a:ext>
              </a:extLst>
            </p:cNvPr>
            <p:cNvSpPr txBox="1"/>
            <p:nvPr/>
          </p:nvSpPr>
          <p:spPr>
            <a:xfrm>
              <a:off x="2086931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4</a:t>
              </a: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444A171B-C64D-D9D4-2589-E46CDD4249D4}"/>
                </a:ext>
              </a:extLst>
            </p:cNvPr>
            <p:cNvSpPr txBox="1"/>
            <p:nvPr/>
          </p:nvSpPr>
          <p:spPr>
            <a:xfrm>
              <a:off x="2339235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5</a:t>
              </a:r>
            </a:p>
          </p:txBody>
        </p:sp>
      </p:grpSp>
      <p:grpSp>
        <p:nvGrpSpPr>
          <p:cNvPr id="144" name="グループ化 143">
            <a:extLst>
              <a:ext uri="{FF2B5EF4-FFF2-40B4-BE49-F238E27FC236}">
                <a16:creationId xmlns:a16="http://schemas.microsoft.com/office/drawing/2014/main" id="{C21024A8-37D0-09AC-5636-D01604BF9D29}"/>
              </a:ext>
            </a:extLst>
          </p:cNvPr>
          <p:cNvGrpSpPr/>
          <p:nvPr/>
        </p:nvGrpSpPr>
        <p:grpSpPr>
          <a:xfrm>
            <a:off x="4150343" y="611177"/>
            <a:ext cx="1628162" cy="215444"/>
            <a:chOff x="1178622" y="2836148"/>
            <a:chExt cx="1567616" cy="215444"/>
          </a:xfrm>
        </p:grpSpPr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F1CF58FF-3F94-660C-53AF-BEC08E781419}"/>
                </a:ext>
              </a:extLst>
            </p:cNvPr>
            <p:cNvSpPr txBox="1"/>
            <p:nvPr/>
          </p:nvSpPr>
          <p:spPr>
            <a:xfrm>
              <a:off x="1178622" y="2836148"/>
              <a:ext cx="38505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2FC15F3C-4D35-BAE6-366B-DCC08D60BED4}"/>
                </a:ext>
              </a:extLst>
            </p:cNvPr>
            <p:cNvSpPr txBox="1"/>
            <p:nvPr/>
          </p:nvSpPr>
          <p:spPr>
            <a:xfrm>
              <a:off x="1396217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1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D2695A3A-27BC-81EE-9F40-61B486BEBE27}"/>
                </a:ext>
              </a:extLst>
            </p:cNvPr>
            <p:cNvSpPr txBox="1"/>
            <p:nvPr/>
          </p:nvSpPr>
          <p:spPr>
            <a:xfrm>
              <a:off x="1618471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2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F9673850-02C4-E23D-9C05-86C3415655EC}"/>
                </a:ext>
              </a:extLst>
            </p:cNvPr>
            <p:cNvSpPr txBox="1"/>
            <p:nvPr/>
          </p:nvSpPr>
          <p:spPr>
            <a:xfrm>
              <a:off x="1853704" y="2836148"/>
              <a:ext cx="4160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3</a:t>
              </a: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150C1053-A058-D73E-D5CB-80D931965123}"/>
                </a:ext>
              </a:extLst>
            </p:cNvPr>
            <p:cNvSpPr txBox="1"/>
            <p:nvPr/>
          </p:nvSpPr>
          <p:spPr>
            <a:xfrm>
              <a:off x="2086931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4</a:t>
              </a: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F907E566-D0E1-A2FD-2C00-4D74D520D385}"/>
                </a:ext>
              </a:extLst>
            </p:cNvPr>
            <p:cNvSpPr txBox="1"/>
            <p:nvPr/>
          </p:nvSpPr>
          <p:spPr>
            <a:xfrm>
              <a:off x="2339235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5</a:t>
              </a:r>
            </a:p>
          </p:txBody>
        </p:sp>
      </p:grp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D4E9E07F-E8E7-CA48-2EAA-A738AFC424B6}"/>
              </a:ext>
            </a:extLst>
          </p:cNvPr>
          <p:cNvGrpSpPr/>
          <p:nvPr/>
        </p:nvGrpSpPr>
        <p:grpSpPr>
          <a:xfrm>
            <a:off x="4226001" y="2402465"/>
            <a:ext cx="1628162" cy="215444"/>
            <a:chOff x="1178622" y="2836148"/>
            <a:chExt cx="1567616" cy="215444"/>
          </a:xfrm>
        </p:grpSpPr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31A72611-257A-6DE2-57BA-A13903248738}"/>
                </a:ext>
              </a:extLst>
            </p:cNvPr>
            <p:cNvSpPr txBox="1"/>
            <p:nvPr/>
          </p:nvSpPr>
          <p:spPr>
            <a:xfrm>
              <a:off x="1178622" y="2836148"/>
              <a:ext cx="38505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957EB000-D3E4-FCE8-06C3-3D6DABBE6CF9}"/>
                </a:ext>
              </a:extLst>
            </p:cNvPr>
            <p:cNvSpPr txBox="1"/>
            <p:nvPr/>
          </p:nvSpPr>
          <p:spPr>
            <a:xfrm>
              <a:off x="1396217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1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58E987B1-267B-C278-74AD-FA7AB9E4B7BF}"/>
                </a:ext>
              </a:extLst>
            </p:cNvPr>
            <p:cNvSpPr txBox="1"/>
            <p:nvPr/>
          </p:nvSpPr>
          <p:spPr>
            <a:xfrm>
              <a:off x="1618471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2</a:t>
              </a:r>
              <a:endParaRPr kumimoji="1" lang="ja-JP" altLang="en-US" sz="8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285F4B51-8873-89A0-C8F1-9C5E67205792}"/>
                </a:ext>
              </a:extLst>
            </p:cNvPr>
            <p:cNvSpPr txBox="1"/>
            <p:nvPr/>
          </p:nvSpPr>
          <p:spPr>
            <a:xfrm>
              <a:off x="1853704" y="2836148"/>
              <a:ext cx="4160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3</a:t>
              </a: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367A4149-F17D-9C6C-B279-8BC17D30A970}"/>
                </a:ext>
              </a:extLst>
            </p:cNvPr>
            <p:cNvSpPr txBox="1"/>
            <p:nvPr/>
          </p:nvSpPr>
          <p:spPr>
            <a:xfrm>
              <a:off x="2086931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4</a:t>
              </a: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AF4A88C3-D546-8637-DC4D-29CACB8014F1}"/>
                </a:ext>
              </a:extLst>
            </p:cNvPr>
            <p:cNvSpPr txBox="1"/>
            <p:nvPr/>
          </p:nvSpPr>
          <p:spPr>
            <a:xfrm>
              <a:off x="2339235" y="2836148"/>
              <a:ext cx="4070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A5</a:t>
              </a:r>
            </a:p>
          </p:txBody>
        </p:sp>
      </p:grp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4A13F143-55CC-1C47-5C13-D1288724F636}"/>
              </a:ext>
            </a:extLst>
          </p:cNvPr>
          <p:cNvSpPr txBox="1"/>
          <p:nvPr/>
        </p:nvSpPr>
        <p:spPr>
          <a:xfrm>
            <a:off x="486905" y="346108"/>
            <a:ext cx="2547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aw data for Fig. 4C (upper panel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076079FD-7192-E14F-39E4-7467AADBBCD3}"/>
              </a:ext>
            </a:extLst>
          </p:cNvPr>
          <p:cNvSpPr txBox="1"/>
          <p:nvPr/>
        </p:nvSpPr>
        <p:spPr>
          <a:xfrm>
            <a:off x="490912" y="2171595"/>
            <a:ext cx="25394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aw data for Fig. 4E (upper panel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F387833A-4150-CB24-A4A4-149D5A9684E4}"/>
              </a:ext>
            </a:extLst>
          </p:cNvPr>
          <p:cNvSpPr txBox="1"/>
          <p:nvPr/>
        </p:nvSpPr>
        <p:spPr>
          <a:xfrm>
            <a:off x="1035599" y="6370894"/>
            <a:ext cx="4805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riginal (non-normalized) data for Fig. 4E</a:t>
            </a:r>
            <a:r>
              <a:rPr lang="ja-JP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5E4C8CD6-274A-AA5F-3347-01AEE51CEA70}"/>
              </a:ext>
            </a:extLst>
          </p:cNvPr>
          <p:cNvSpPr txBox="1"/>
          <p:nvPr/>
        </p:nvSpPr>
        <p:spPr>
          <a:xfrm>
            <a:off x="1512926" y="5494407"/>
            <a:ext cx="39068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aw data for Fig. 4C and E</a:t>
            </a:r>
            <a:r>
              <a:rPr lang="ja-JP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27C4F919-9F14-4FF3-0EBE-8EEBA68FD262}"/>
              </a:ext>
            </a:extLst>
          </p:cNvPr>
          <p:cNvSpPr txBox="1"/>
          <p:nvPr/>
        </p:nvSpPr>
        <p:spPr>
          <a:xfrm>
            <a:off x="4760237" y="8155007"/>
            <a:ext cx="10534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Arbitrary units</a:t>
            </a:r>
            <a:endParaRPr kumimoji="1" lang="ja-JP" altLang="en-US" sz="105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5" name="図 164">
            <a:extLst>
              <a:ext uri="{FF2B5EF4-FFF2-40B4-BE49-F238E27FC236}">
                <a16:creationId xmlns:a16="http://schemas.microsoft.com/office/drawing/2014/main" id="{C8991EF6-1A74-0F89-FE4F-18DBBC10C57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26972" y="6715345"/>
            <a:ext cx="4622800" cy="1460500"/>
          </a:xfrm>
          <a:prstGeom prst="rect">
            <a:avLst/>
          </a:prstGeom>
        </p:spPr>
      </p:pic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8F20B4B1-A2E2-5507-4861-F04E5467C158}"/>
              </a:ext>
            </a:extLst>
          </p:cNvPr>
          <p:cNvCxnSpPr/>
          <p:nvPr/>
        </p:nvCxnSpPr>
        <p:spPr>
          <a:xfrm>
            <a:off x="1126972" y="6715345"/>
            <a:ext cx="4622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8" name="直線コネクタ 167">
            <a:extLst>
              <a:ext uri="{FF2B5EF4-FFF2-40B4-BE49-F238E27FC236}">
                <a16:creationId xmlns:a16="http://schemas.microsoft.com/office/drawing/2014/main" id="{1C38E408-51A4-B016-59AB-E816D4AEA0ED}"/>
              </a:ext>
            </a:extLst>
          </p:cNvPr>
          <p:cNvCxnSpPr/>
          <p:nvPr/>
        </p:nvCxnSpPr>
        <p:spPr>
          <a:xfrm>
            <a:off x="1126972" y="6928257"/>
            <a:ext cx="4622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9" name="直線コネクタ 168">
            <a:extLst>
              <a:ext uri="{FF2B5EF4-FFF2-40B4-BE49-F238E27FC236}">
                <a16:creationId xmlns:a16="http://schemas.microsoft.com/office/drawing/2014/main" id="{AD47E142-CE2E-D16B-2EB8-9B821D2FA8D3}"/>
              </a:ext>
            </a:extLst>
          </p:cNvPr>
          <p:cNvCxnSpPr/>
          <p:nvPr/>
        </p:nvCxnSpPr>
        <p:spPr>
          <a:xfrm>
            <a:off x="1126972" y="8155007"/>
            <a:ext cx="4622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FA2623A2-C0C3-4E59-D877-5227FE3A5702}"/>
              </a:ext>
            </a:extLst>
          </p:cNvPr>
          <p:cNvSpPr txBox="1"/>
          <p:nvPr/>
        </p:nvSpPr>
        <p:spPr>
          <a:xfrm>
            <a:off x="3725038" y="346108"/>
            <a:ext cx="252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aw data for Fig. 4C (lower panel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C1B22B41-F00B-D33E-5D0C-A56771517883}"/>
              </a:ext>
            </a:extLst>
          </p:cNvPr>
          <p:cNvSpPr txBox="1"/>
          <p:nvPr/>
        </p:nvSpPr>
        <p:spPr>
          <a:xfrm>
            <a:off x="3729045" y="2171595"/>
            <a:ext cx="25138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aw data for Fig. 4E (lower panel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7502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1</TotalTime>
  <Words>124</Words>
  <Application>Microsoft Macintosh PowerPoint</Application>
  <PresentationFormat>画面に合わせる (4:3)</PresentationFormat>
  <Paragraphs>6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ku Nedachi</dc:creator>
  <cp:lastModifiedBy>Taku Nedachi</cp:lastModifiedBy>
  <cp:revision>5</cp:revision>
  <dcterms:created xsi:type="dcterms:W3CDTF">2026-04-22T13:08:42Z</dcterms:created>
  <dcterms:modified xsi:type="dcterms:W3CDTF">2026-04-28T09:13:00Z</dcterms:modified>
</cp:coreProperties>
</file>